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5" d="100"/>
          <a:sy n="85" d="100"/>
        </p:scale>
        <p:origin x="74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A86AE74-E2B5-4068-8897-29D8C502FDC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50DD6297-0FCA-499A-A50E-01BD3E91F18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E118995-E468-4654-9419-3DB4F539F1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6AB85-ADD9-4A76-8C2F-13B8DAE257A0}" type="datetimeFigureOut">
              <a:rPr lang="zh-CN" altLang="en-US" smtClean="0"/>
              <a:t>2022/1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8D4FEF4-C652-4384-9B3E-1CEF533747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F41AFC4-4660-4390-B18A-3D354D02FE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6FF24-EED3-4F4D-B9AC-14B0C9BBDC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15512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B8CFC73-4F20-4C50-B083-AC90741C19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3BB49DE-B1B4-4DB3-B6EF-721ECB1254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C7D48FB-11C3-4F51-9E92-B10EEC1929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6AB85-ADD9-4A76-8C2F-13B8DAE257A0}" type="datetimeFigureOut">
              <a:rPr lang="zh-CN" altLang="en-US" smtClean="0"/>
              <a:t>2022/1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AC525E9-95BA-43B8-A5FD-3F72ABCF23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8E1CC3D-1080-49F1-B681-49726BFACC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6FF24-EED3-4F4D-B9AC-14B0C9BBDC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4742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D8B282C2-5E3A-4297-A60A-288E20BF0D5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D2D7003-DC17-4909-B939-4F8861E9A3A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E62C64F-D325-4D64-A3E5-176B143A00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6AB85-ADD9-4A76-8C2F-13B8DAE257A0}" type="datetimeFigureOut">
              <a:rPr lang="zh-CN" altLang="en-US" smtClean="0"/>
              <a:t>2022/1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73428A4-982E-4B2D-B15A-F3E49C1718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35BD7C1-0C76-4D04-89D3-EA60DD00AD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6FF24-EED3-4F4D-B9AC-14B0C9BBDC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12177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49BBE17-07B7-4089-8A4D-6F35C0B443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27E718F-E197-4587-B2D0-D5D3D86D4DC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DA8BC8D-0604-431B-A8BA-B2FA322609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6AB85-ADD9-4A76-8C2F-13B8DAE257A0}" type="datetimeFigureOut">
              <a:rPr lang="zh-CN" altLang="en-US" smtClean="0"/>
              <a:t>2022/1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8DC5F32-A775-4973-95B7-E6D4F3C692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37200F2-D15D-4457-9D5A-2C8127D4E9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6FF24-EED3-4F4D-B9AC-14B0C9BBDC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53724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40C428C-08BE-4272-8620-169CCBCA86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1ED1F08-7B6C-4EDF-9FE2-DDBDAA5E43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69F93D8-2A5B-42F8-BD08-4D52E63C41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6AB85-ADD9-4A76-8C2F-13B8DAE257A0}" type="datetimeFigureOut">
              <a:rPr lang="zh-CN" altLang="en-US" smtClean="0"/>
              <a:t>2022/1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3A64F2C-53BD-4B37-A6E6-FAE48C2D68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0E4342C-D4B4-4A69-839C-1487916D03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6FF24-EED3-4F4D-B9AC-14B0C9BBDC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88389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3B5AA7A-3100-41CD-B380-ACF17560CF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51C0772-53B8-4249-BC64-2D325AF9A6A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5AC67CB-B1E5-4119-BD96-156135ADDB6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1C60345-A77D-4E01-A18E-0FE28E450E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6AB85-ADD9-4A76-8C2F-13B8DAE257A0}" type="datetimeFigureOut">
              <a:rPr lang="zh-CN" altLang="en-US" smtClean="0"/>
              <a:t>2022/1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139CB37-6772-41C0-9CC7-B2D8BFBD5A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44F7BD6-296E-4E90-9B17-82E6834BF5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6FF24-EED3-4F4D-B9AC-14B0C9BBDC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84391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F0CF367-E4CD-496A-8E6C-60932664E6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BEBE269-1109-4B95-989B-B79A35A0A6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20C20EA-89FF-4356-8250-BC897F6ADD9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B655FE6C-D4BA-4A9B-9775-A7F02560BF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D9CEF195-0144-4229-8BC6-5BCC4BE8D63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A9E6E5C-7C82-4061-ABE5-7CD716F8F7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6AB85-ADD9-4A76-8C2F-13B8DAE257A0}" type="datetimeFigureOut">
              <a:rPr lang="zh-CN" altLang="en-US" smtClean="0"/>
              <a:t>2022/1/2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7C144384-3013-4BEC-BE26-8EFA3934C6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BE41C65A-AA8C-4357-91E8-0619E8490A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6FF24-EED3-4F4D-B9AC-14B0C9BBDC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91155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CC40BCA-41B7-492D-BE8D-F1E13C2283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8D3387F9-E0A8-468A-B2EA-4D9DB2008A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6AB85-ADD9-4A76-8C2F-13B8DAE257A0}" type="datetimeFigureOut">
              <a:rPr lang="zh-CN" altLang="en-US" smtClean="0"/>
              <a:t>2022/1/2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F4A24751-444F-424C-BCD1-E2760C2E6A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987154B4-5764-456B-9ACE-3CEEACBD40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6FF24-EED3-4F4D-B9AC-14B0C9BBDC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13021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960EC82-483E-4613-95DE-FDBB0B91B9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6AB85-ADD9-4A76-8C2F-13B8DAE257A0}" type="datetimeFigureOut">
              <a:rPr lang="zh-CN" altLang="en-US" smtClean="0"/>
              <a:t>2022/1/2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2AE7B0C-1567-4B81-A143-3BAAB0552C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753AC922-9FA3-46DF-A50D-C1C6AC6D9E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6FF24-EED3-4F4D-B9AC-14B0C9BBDC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36701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8047F02-473A-4BBF-BF96-64267480BA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2D13D43-AA84-4D5E-85A2-CAADF5C966A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C14F55D-52FF-4F25-AB71-84902977C6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93BE554-FA74-4BFD-983A-D5C43F865D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6AB85-ADD9-4A76-8C2F-13B8DAE257A0}" type="datetimeFigureOut">
              <a:rPr lang="zh-CN" altLang="en-US" smtClean="0"/>
              <a:t>2022/1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94C93DD-6D32-4B4B-B86B-5D7505CEB1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4C3CBED-1B0A-4751-BEFE-4C140BDAB3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6FF24-EED3-4F4D-B9AC-14B0C9BBDC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89574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FDD87E8-0C4E-45B8-9CF7-8388389F63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898CB1B-87DA-40B6-BA0B-A39DAFAE478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4599663-1307-4DE6-9B3E-727C6EA99C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21E2E0F-3C91-4E81-BC03-CE7A7F39EB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6AB85-ADD9-4A76-8C2F-13B8DAE257A0}" type="datetimeFigureOut">
              <a:rPr lang="zh-CN" altLang="en-US" smtClean="0"/>
              <a:t>2022/1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997A988-18C4-4F24-A544-3A4D9F4E62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B8A07EA-E748-4007-85C6-792D1E73D0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6FF24-EED3-4F4D-B9AC-14B0C9BBDC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11560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BC1A565-0A49-4A9E-BE9B-6734BEAB64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380EE89-C43E-4E40-87A6-804097CF09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37FD2BD-8831-43ED-857B-A820F1099E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36AB85-ADD9-4A76-8C2F-13B8DAE257A0}" type="datetimeFigureOut">
              <a:rPr lang="zh-CN" altLang="en-US" smtClean="0"/>
              <a:t>2022/1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0516F08-1DB1-44F2-8CDF-7EAF89BDE87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3B63FF5-60EA-4335-A87F-D3053A39C77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46FF24-EED3-4F4D-B9AC-14B0C9BBDC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32797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190C1AD6-2814-4CE9-85D6-4ED83A32C105}"/>
              </a:ext>
            </a:extLst>
          </p:cNvPr>
          <p:cNvSpPr txBox="1"/>
          <p:nvPr/>
        </p:nvSpPr>
        <p:spPr>
          <a:xfrm>
            <a:off x="1514118" y="5705102"/>
            <a:ext cx="955236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 3S</a:t>
            </a:r>
            <a:r>
              <a:rPr lang="en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zh-CN" altLang="en-US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ntagonistic assay of </a:t>
            </a:r>
            <a:r>
              <a:rPr lang="en-US" altLang="zh-CN" sz="16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L. plantarum </a:t>
            </a:r>
            <a:r>
              <a:rPr lang="en-US" altLang="zh-CN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S-09 against </a:t>
            </a:r>
            <a:r>
              <a:rPr lang="en-US" altLang="zh-CN" sz="16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altLang="zh-CN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yphimurium. An Oxford cup test was executed.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图片 11" descr="图片包含 杯子, 桌子, 关, 锣&#10;&#10;描述已自动生成">
            <a:extLst>
              <a:ext uri="{FF2B5EF4-FFF2-40B4-BE49-F238E27FC236}">
                <a16:creationId xmlns:a16="http://schemas.microsoft.com/office/drawing/2014/main" id="{E8D46C05-4549-48DB-8AA0-7E4961B17A5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92181" y="735322"/>
            <a:ext cx="4796234" cy="47962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277990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F2F70E27-60C7-46D6-A0B8-A29AA2B8226F}"/>
              </a:ext>
            </a:extLst>
          </p:cNvPr>
          <p:cNvSpPr txBox="1"/>
          <p:nvPr/>
        </p:nvSpPr>
        <p:spPr>
          <a:xfrm>
            <a:off x="1423807" y="5750258"/>
            <a:ext cx="955236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 6S</a:t>
            </a:r>
            <a:r>
              <a:rPr lang="en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zh-CN" altLang="en-US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tection of </a:t>
            </a:r>
            <a:r>
              <a:rPr lang="en-US" altLang="zh-CN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1 macrophages in the mesenteric lymph nodes in vivo by flow cytometry.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E1ADF37E-9F57-4271-8989-44D0CE80AEE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494" t="6944" r="49185" b="12694"/>
          <a:stretch/>
        </p:blipFill>
        <p:spPr>
          <a:xfrm>
            <a:off x="7347319" y="2617304"/>
            <a:ext cx="2335337" cy="2394077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07172E94-A2E3-42B0-87F5-E807A9C9195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576" t="5830" r="48110" b="12320"/>
          <a:stretch/>
        </p:blipFill>
        <p:spPr>
          <a:xfrm>
            <a:off x="4851574" y="2616754"/>
            <a:ext cx="2335338" cy="2386132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CCA962F5-B941-45DF-B8D2-BB820BA34E1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591" t="6620" r="48522" b="14011"/>
          <a:stretch/>
        </p:blipFill>
        <p:spPr>
          <a:xfrm>
            <a:off x="2516668" y="2651068"/>
            <a:ext cx="2265246" cy="2265247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B0DFF264-D8DB-4A2B-8E02-DF0E7A4B41C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5467" t="6622" r="48646" b="14008"/>
          <a:stretch/>
        </p:blipFill>
        <p:spPr>
          <a:xfrm>
            <a:off x="4851677" y="313770"/>
            <a:ext cx="2265245" cy="2265246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58B00976-43A4-4769-9706-08FA402347A1}"/>
              </a:ext>
            </a:extLst>
          </p:cNvPr>
          <p:cNvSpPr txBox="1"/>
          <p:nvPr/>
        </p:nvSpPr>
        <p:spPr>
          <a:xfrm>
            <a:off x="6357722" y="1515932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F9A8FC4F-1976-4B25-9D16-9636F7B4FE5D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5754" t="6265" r="48360" b="13414"/>
          <a:stretch/>
        </p:blipFill>
        <p:spPr>
          <a:xfrm>
            <a:off x="2521487" y="313770"/>
            <a:ext cx="2238389" cy="2265246"/>
          </a:xfrm>
          <a:prstGeom prst="rect">
            <a:avLst/>
          </a:prstGeom>
        </p:spPr>
      </p:pic>
      <p:cxnSp>
        <p:nvCxnSpPr>
          <p:cNvPr id="11" name="直接箭头连接符 10">
            <a:extLst>
              <a:ext uri="{FF2B5EF4-FFF2-40B4-BE49-F238E27FC236}">
                <a16:creationId xmlns:a16="http://schemas.microsoft.com/office/drawing/2014/main" id="{87094492-D611-4979-B1CA-305283BC9AC5}"/>
              </a:ext>
            </a:extLst>
          </p:cNvPr>
          <p:cNvCxnSpPr>
            <a:cxnSpLocks/>
          </p:cNvCxnSpPr>
          <p:nvPr/>
        </p:nvCxnSpPr>
        <p:spPr>
          <a:xfrm>
            <a:off x="2079992" y="5089456"/>
            <a:ext cx="7919675" cy="26996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直接箭头连接符 11">
            <a:extLst>
              <a:ext uri="{FF2B5EF4-FFF2-40B4-BE49-F238E27FC236}">
                <a16:creationId xmlns:a16="http://schemas.microsoft.com/office/drawing/2014/main" id="{FD319AA6-E597-4A3F-BE34-BD22EC19B722}"/>
              </a:ext>
            </a:extLst>
          </p:cNvPr>
          <p:cNvCxnSpPr>
            <a:cxnSpLocks/>
          </p:cNvCxnSpPr>
          <p:nvPr/>
        </p:nvCxnSpPr>
        <p:spPr>
          <a:xfrm flipV="1">
            <a:off x="2079994" y="256733"/>
            <a:ext cx="0" cy="483272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30105727-DD81-4C07-B093-789BE22D8783}"/>
              </a:ext>
            </a:extLst>
          </p:cNvPr>
          <p:cNvSpPr txBox="1"/>
          <p:nvPr/>
        </p:nvSpPr>
        <p:spPr>
          <a:xfrm>
            <a:off x="3821067" y="1546710"/>
            <a:ext cx="7585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gative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8318A053-B0BE-4AE1-AE77-D84CF4952557}"/>
              </a:ext>
            </a:extLst>
          </p:cNvPr>
          <p:cNvSpPr txBox="1"/>
          <p:nvPr/>
        </p:nvSpPr>
        <p:spPr>
          <a:xfrm>
            <a:off x="6193414" y="3899754"/>
            <a:ext cx="7825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y14028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D115BF59-7E7C-4E19-9405-5DF2FAC82FC0}"/>
              </a:ext>
            </a:extLst>
          </p:cNvPr>
          <p:cNvSpPr txBox="1"/>
          <p:nvPr/>
        </p:nvSpPr>
        <p:spPr>
          <a:xfrm>
            <a:off x="3878130" y="3904705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S-09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B14ED2C3-2503-4F72-B725-1876378A0657}"/>
              </a:ext>
            </a:extLst>
          </p:cNvPr>
          <p:cNvSpPr txBox="1"/>
          <p:nvPr/>
        </p:nvSpPr>
        <p:spPr>
          <a:xfrm>
            <a:off x="8360410" y="3899754"/>
            <a:ext cx="14886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S-09+Sty14028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E53F5528-ACC1-4D6F-836C-BA318028E686}"/>
              </a:ext>
            </a:extLst>
          </p:cNvPr>
          <p:cNvSpPr txBox="1"/>
          <p:nvPr/>
        </p:nvSpPr>
        <p:spPr>
          <a:xfrm>
            <a:off x="2381578" y="5168884"/>
            <a:ext cx="13545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</a:t>
            </a:r>
            <a:r>
              <a:rPr lang="en-US" altLang="zh-CN" sz="16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4/80</a:t>
            </a:r>
            <a:r>
              <a: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FITC</a:t>
            </a:r>
            <a:endParaRPr kumimoji="0" lang="zh-CN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4297D4F8-6A6A-4101-B07C-D31E5501A0C5}"/>
              </a:ext>
            </a:extLst>
          </p:cNvPr>
          <p:cNvSpPr txBox="1"/>
          <p:nvPr/>
        </p:nvSpPr>
        <p:spPr>
          <a:xfrm rot="16200000">
            <a:off x="1259329" y="3551591"/>
            <a:ext cx="1282018" cy="338554"/>
          </a:xfrm>
          <a:prstGeom prst="rect">
            <a:avLst/>
          </a:prstGeom>
          <a:noFill/>
          <a:ln w="38100">
            <a:noFill/>
          </a:ln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D11c-PE</a:t>
            </a:r>
            <a:endParaRPr kumimoji="0" lang="zh-CN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796056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4D0E9E4D-1345-402D-B2C8-AC7C8718675A}"/>
              </a:ext>
            </a:extLst>
          </p:cNvPr>
          <p:cNvSpPr txBox="1"/>
          <p:nvPr/>
        </p:nvSpPr>
        <p:spPr>
          <a:xfrm>
            <a:off x="2726970" y="5366435"/>
            <a:ext cx="7026630" cy="61555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 7S</a:t>
            </a:r>
            <a:r>
              <a:rPr lang="en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zh-CN" altLang="en-US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 quantitative fluorescence analysis ROS</a:t>
            </a:r>
            <a:r>
              <a:rPr lang="en-US" altLang="zh-CN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Data are the means ± SD of three independent experiments. </a:t>
            </a:r>
            <a:r>
              <a:rPr lang="en-GB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***</a:t>
            </a:r>
            <a:r>
              <a:rPr lang="en-GB" altLang="zh-CN" sz="18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</a:t>
            </a:r>
            <a:r>
              <a:rPr lang="en-GB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&lt; 0.0001</a:t>
            </a:r>
            <a:r>
              <a:rPr lang="zh-CN" altLang="en-US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。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图片 7" descr="图表, 条形图&#10;&#10;描述已自动生成">
            <a:extLst>
              <a:ext uri="{FF2B5EF4-FFF2-40B4-BE49-F238E27FC236}">
                <a16:creationId xmlns:a16="http://schemas.microsoft.com/office/drawing/2014/main" id="{9ABA2AC3-5BD7-408B-84AD-5CAB0D881E0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3072" y="783518"/>
            <a:ext cx="4877418" cy="44765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952055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1</TotalTime>
  <Words>74</Words>
  <Application>Microsoft Office PowerPoint</Application>
  <PresentationFormat>宽屏</PresentationFormat>
  <Paragraphs>10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wzhu</dc:creator>
  <cp:lastModifiedBy>hwzhu</cp:lastModifiedBy>
  <cp:revision>15</cp:revision>
  <dcterms:created xsi:type="dcterms:W3CDTF">2022-01-14T08:09:51Z</dcterms:created>
  <dcterms:modified xsi:type="dcterms:W3CDTF">2022-01-24T14:10:21Z</dcterms:modified>
</cp:coreProperties>
</file>